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03"/>
    <p:restoredTop sz="94694"/>
  </p:normalViewPr>
  <p:slideViewPr>
    <p:cSldViewPr snapToGrid="0">
      <p:cViewPr>
        <p:scale>
          <a:sx n="84" d="100"/>
          <a:sy n="84" d="100"/>
        </p:scale>
        <p:origin x="2184" y="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682AC-4BF2-4DF8-9CB1-F40B035360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C02AED-14C0-42BF-9634-AAE4D73AD5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D66AC-8DF8-4A11-9C81-43509307D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E448B3-C5B8-4BCE-A173-64C4994D1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F5243E-8DFB-44E9-8669-998B20C94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176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2BD44-153E-439C-935A-6FE5E19B1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28E037-7DCC-4770-87D6-AE30FC569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C7606-7B6C-42E9-BC6B-20CE17EF9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332674-6DE0-4915-8164-FCDD72287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1DDA34-FE24-45F8-A43E-1FDB06D72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045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E8E808-70D5-49AF-9083-8D3C8DF873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10806E-B917-43CB-97BC-1E3C62B97C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DA302-B04B-4425-A3B6-C2BCBF863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8C395F-FDF2-4830-9216-4B605E754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90677-BDF7-4569-86A9-0304AE728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25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FDE26-47C0-4C83-BD62-71979BC66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6CFA4B-2509-44F3-B8B8-E82FFEDECE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4F29B-C4FD-420F-A68B-4CEB5D914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9FFD2D-19AF-47B6-9273-3FD7B7794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96FB5-9FC9-4AFC-8477-262024CA4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684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D5AED-4EA4-43FF-A057-003562189E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96F6C9-5BB4-425E-9209-F68B27E85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CEB4DB-EC17-46DF-948A-9E51777AA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239B5F-66E4-4061-8446-3E17B315A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5533A-7D2C-4A95-9EE9-DA0790A53F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005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171C7-0EB8-459D-976F-DE9F8876F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BAD58-93AB-4F01-A1D4-50B264CA63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694BC1-09E9-4F12-9FFC-DF5299355A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C2517E-74D2-452E-9ADD-202992F4C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3CB2B2-C95C-4FC9-82C3-C44117D1A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8B6851-E594-4D61-B39D-D16A8A7B6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359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0B6CBA-64EB-4B39-A567-B7F4A4DC1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5E769A-EF2F-475F-B301-1E42C00DB7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917065-9506-4A7F-92F0-4805B01C46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1D6A4C-FC97-4594-B1BB-A8CD3B3C28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50B65A-B49C-47E9-B5DD-638D611BBB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61054C-D8AD-45BC-907E-5CA657418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A36944-8307-48D7-9A9A-A2A560438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FA14DC-BC3A-4281-9FDB-6A922EEA7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982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EFCEC-B69E-4D11-A3D2-77FE0BACE7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DD09F5-6105-491C-890F-B6CCDED88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708E92-819F-4A28-B0F9-29270FA5D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00C1A1-E6CE-4392-A75D-28E1409BB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601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354383-5C7B-4477-8BA7-0DDDD03BF6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FF45E4-EBCD-4B97-AD92-38EFF03BC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27D752-DC0C-4179-94E3-2AFEBFDEE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246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3960A-DF47-4BD0-ABD2-97AEB5901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9307DB-848B-4A9A-AE78-45C4713CB1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92E0BE-42C7-4D5D-89A2-B7AADFECAC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996A47-EE8C-472D-B733-21F5EF43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AB89F4-2B6D-43BC-A243-A30F18576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A58C4B-A704-4B6D-80AB-00D2B157A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990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CB64E-F1EB-4B00-AE6D-43A2773BE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8541D2-BB4D-47BE-A6D7-B8BE766A2B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9CCCA0-59EF-405D-8D3E-16CA03727B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FD369E-C8CF-4473-9A15-2DA39C278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A7A5C9-E5BD-48A6-A05C-6ED2FCBE2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CB950F-961F-4A1A-A5EE-E575C7E25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855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D9A1F9-6BA5-41E9-A2E4-8857DC366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3EBB47-04D0-4A3F-82EF-5B2B179CD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AE8986-9D15-4385-AB56-E7C388C830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F0043-86E0-4064-AEB1-0DDB1D250F1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398536-502A-4953-AFFB-189F8EA663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A59F80-8516-4E4D-8948-B72771C93F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6A3C9-F919-4346-950C-B2D2D5232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023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10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7.e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7.bin"/><Relationship Id="rId5" Type="http://schemas.openxmlformats.org/officeDocument/2006/relationships/image" Target="../media/image16.emf"/><Relationship Id="rId4" Type="http://schemas.openxmlformats.org/officeDocument/2006/relationships/oleObject" Target="../embeddings/oleObject16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oleObject" Target="../embeddings/oleObject18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emf"/><Relationship Id="rId4" Type="http://schemas.openxmlformats.org/officeDocument/2006/relationships/oleObject" Target="../embeddings/oleObject19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2.emf"/><Relationship Id="rId2" Type="http://schemas.openxmlformats.org/officeDocument/2006/relationships/oleObject" Target="../embeddings/oleObject20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2.bin"/><Relationship Id="rId5" Type="http://schemas.openxmlformats.org/officeDocument/2006/relationships/image" Target="../media/image21.emf"/><Relationship Id="rId4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7F0901-42CD-4218-A15F-86107F3D9C00}"/>
              </a:ext>
            </a:extLst>
          </p:cNvPr>
          <p:cNvSpPr txBox="1"/>
          <p:nvPr/>
        </p:nvSpPr>
        <p:spPr>
          <a:xfrm>
            <a:off x="410817" y="463826"/>
            <a:ext cx="1117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C.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D330905-14EE-4A2E-8A36-EB9DB373C4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5401053"/>
              </p:ext>
            </p:extLst>
          </p:nvPr>
        </p:nvGraphicFramePr>
        <p:xfrm>
          <a:off x="2858602" y="440351"/>
          <a:ext cx="4101403" cy="1322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258747" imgH="728334" progId="">
                  <p:embed/>
                </p:oleObj>
              </mc:Choice>
              <mc:Fallback>
                <p:oleObj r:id="rId2" imgW="2258747" imgH="7283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58602" y="440351"/>
                        <a:ext cx="4101403" cy="1322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1BB65B62-DF03-4D63-B2C7-312C232F2E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9074204"/>
              </p:ext>
            </p:extLst>
          </p:nvPr>
        </p:nvGraphicFramePr>
        <p:xfrm>
          <a:off x="2858604" y="3548196"/>
          <a:ext cx="4101403" cy="1322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258747" imgH="728334" progId="">
                  <p:embed/>
                </p:oleObj>
              </mc:Choice>
              <mc:Fallback>
                <p:oleObj r:id="rId4" imgW="2258747" imgH="7283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58604" y="3548196"/>
                        <a:ext cx="4101403" cy="1322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07914BE-CC5A-419B-BE7C-00EF4A3CE9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0692438"/>
              </p:ext>
            </p:extLst>
          </p:nvPr>
        </p:nvGraphicFramePr>
        <p:xfrm>
          <a:off x="2858602" y="2130073"/>
          <a:ext cx="4101403" cy="1322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258747" imgH="728334" progId="">
                  <p:embed/>
                </p:oleObj>
              </mc:Choice>
              <mc:Fallback>
                <p:oleObj r:id="rId6" imgW="2258747" imgH="7283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858602" y="2130073"/>
                        <a:ext cx="4101403" cy="1322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C5641D7-17A6-415A-B158-FF1F658E0F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722109"/>
              </p:ext>
            </p:extLst>
          </p:nvPr>
        </p:nvGraphicFramePr>
        <p:xfrm>
          <a:off x="2858601" y="4749928"/>
          <a:ext cx="4101405" cy="1322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258747" imgH="728334" progId="">
                  <p:embed/>
                </p:oleObj>
              </mc:Choice>
              <mc:Fallback>
                <p:oleObj r:id="rId8" imgW="2258747" imgH="7283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58601" y="4749928"/>
                        <a:ext cx="4101405" cy="1322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0A427861-5B1E-487A-AC28-2D2423CB0DCF}"/>
              </a:ext>
            </a:extLst>
          </p:cNvPr>
          <p:cNvSpPr txBox="1"/>
          <p:nvPr/>
        </p:nvSpPr>
        <p:spPr>
          <a:xfrm>
            <a:off x="1948069" y="83315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LL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7DD0516-B14D-4B8F-B840-C927B6AB61FD}"/>
              </a:ext>
            </a:extLst>
          </p:cNvPr>
          <p:cNvSpPr txBox="1"/>
          <p:nvPr/>
        </p:nvSpPr>
        <p:spPr>
          <a:xfrm>
            <a:off x="1995374" y="2606877"/>
            <a:ext cx="8361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OA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EBE38F1-247B-4551-91D6-89E57CBF22A1}"/>
              </a:ext>
            </a:extLst>
          </p:cNvPr>
          <p:cNvSpPr txBox="1"/>
          <p:nvPr/>
        </p:nvSpPr>
        <p:spPr>
          <a:xfrm>
            <a:off x="2027818" y="4011264"/>
            <a:ext cx="771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ABP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3526E8-3FEE-481E-AC8C-B7D6078351E7}"/>
              </a:ext>
            </a:extLst>
          </p:cNvPr>
          <p:cNvSpPr txBox="1"/>
          <p:nvPr/>
        </p:nvSpPr>
        <p:spPr>
          <a:xfrm>
            <a:off x="2107452" y="5226732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5EFB714-022B-4B1D-8825-492AC19C60E8}"/>
              </a:ext>
            </a:extLst>
          </p:cNvPr>
          <p:cNvSpPr/>
          <p:nvPr/>
        </p:nvSpPr>
        <p:spPr>
          <a:xfrm>
            <a:off x="5632174" y="785131"/>
            <a:ext cx="95415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C8FFB9B-3F44-47E8-937A-C484B7CF6A4D}"/>
              </a:ext>
            </a:extLst>
          </p:cNvPr>
          <p:cNvSpPr/>
          <p:nvPr/>
        </p:nvSpPr>
        <p:spPr>
          <a:xfrm>
            <a:off x="5632174" y="2166962"/>
            <a:ext cx="95415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8743C50-CEC8-4EF8-BCB0-C18618F454F3}"/>
              </a:ext>
            </a:extLst>
          </p:cNvPr>
          <p:cNvSpPr/>
          <p:nvPr/>
        </p:nvSpPr>
        <p:spPr>
          <a:xfrm>
            <a:off x="5632174" y="3702929"/>
            <a:ext cx="95415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3B20E3F-14D6-4DFE-99DD-3B8189F28D97}"/>
              </a:ext>
            </a:extLst>
          </p:cNvPr>
          <p:cNvSpPr/>
          <p:nvPr/>
        </p:nvSpPr>
        <p:spPr>
          <a:xfrm>
            <a:off x="5528773" y="5112359"/>
            <a:ext cx="95415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8845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6A7508-AF6D-4ABD-93CA-7A2ABC3322DA}"/>
              </a:ext>
            </a:extLst>
          </p:cNvPr>
          <p:cNvSpPr txBox="1"/>
          <p:nvPr/>
        </p:nvSpPr>
        <p:spPr>
          <a:xfrm>
            <a:off x="583096" y="543339"/>
            <a:ext cx="1138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H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326ADAB-79DE-4C8B-A975-AE15059600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8019765"/>
              </p:ext>
            </p:extLst>
          </p:nvPr>
        </p:nvGraphicFramePr>
        <p:xfrm>
          <a:off x="3072365" y="628778"/>
          <a:ext cx="4136818" cy="13773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732442" imgH="910417" progId="">
                  <p:embed/>
                </p:oleObj>
              </mc:Choice>
              <mc:Fallback>
                <p:oleObj r:id="rId2" imgW="2732442" imgH="91041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72365" y="628778"/>
                        <a:ext cx="4136818" cy="13773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CA4261F-29FC-4444-917D-0901CC143C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9415499"/>
              </p:ext>
            </p:extLst>
          </p:nvPr>
        </p:nvGraphicFramePr>
        <p:xfrm>
          <a:off x="3072365" y="1943967"/>
          <a:ext cx="4004296" cy="16224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695866" imgH="1092501" progId="">
                  <p:embed/>
                </p:oleObj>
              </mc:Choice>
              <mc:Fallback>
                <p:oleObj r:id="rId4" imgW="2695866" imgH="1092501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72365" y="1943967"/>
                        <a:ext cx="4004296" cy="16224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ED5FE8D-9F05-4B21-8586-D0CA7A8C0B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1643935"/>
              </p:ext>
            </p:extLst>
          </p:nvPr>
        </p:nvGraphicFramePr>
        <p:xfrm>
          <a:off x="3072365" y="3526422"/>
          <a:ext cx="4050868" cy="1075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695866" imgH="716147" progId="">
                  <p:embed/>
                </p:oleObj>
              </mc:Choice>
              <mc:Fallback>
                <p:oleObj r:id="rId6" imgW="2695866" imgH="71614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72365" y="3526422"/>
                        <a:ext cx="4050868" cy="1075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0908B1D8-CC93-4D4C-B8CA-856932BC9641}"/>
              </a:ext>
            </a:extLst>
          </p:cNvPr>
          <p:cNvSpPr/>
          <p:nvPr/>
        </p:nvSpPr>
        <p:spPr>
          <a:xfrm>
            <a:off x="3310903" y="1071489"/>
            <a:ext cx="3513967" cy="54934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8D420FB-6096-4065-A7AF-1F845DE045F4}"/>
              </a:ext>
            </a:extLst>
          </p:cNvPr>
          <p:cNvSpPr/>
          <p:nvPr/>
        </p:nvSpPr>
        <p:spPr>
          <a:xfrm>
            <a:off x="3397042" y="2282695"/>
            <a:ext cx="3513967" cy="54934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CBFB6AC-1FE7-49A6-903A-625079DDE1BD}"/>
              </a:ext>
            </a:extLst>
          </p:cNvPr>
          <p:cNvSpPr/>
          <p:nvPr/>
        </p:nvSpPr>
        <p:spPr>
          <a:xfrm>
            <a:off x="3436798" y="3814172"/>
            <a:ext cx="3513967" cy="54934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77D1EF-1806-4C0B-9D8D-20C0BE4A8546}"/>
              </a:ext>
            </a:extLst>
          </p:cNvPr>
          <p:cNvSpPr txBox="1"/>
          <p:nvPr/>
        </p:nvSpPr>
        <p:spPr>
          <a:xfrm>
            <a:off x="2156194" y="1116726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illin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9546E6B-BF79-455B-83F9-30C70D14639F}"/>
              </a:ext>
            </a:extLst>
          </p:cNvPr>
          <p:cNvSpPr txBox="1"/>
          <p:nvPr/>
        </p:nvSpPr>
        <p:spPr>
          <a:xfrm>
            <a:off x="2073809" y="2489214"/>
            <a:ext cx="773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RT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657889-C8A4-4C0E-BD1A-2E3757469EC3}"/>
              </a:ext>
            </a:extLst>
          </p:cNvPr>
          <p:cNvSpPr txBox="1"/>
          <p:nvPr/>
        </p:nvSpPr>
        <p:spPr>
          <a:xfrm>
            <a:off x="1614482" y="3901288"/>
            <a:ext cx="13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Na,K</a:t>
            </a:r>
            <a:r>
              <a:rPr lang="en-US" dirty="0"/>
              <a:t>-ATPas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72F736-E037-4C00-93DA-AEAEDB65BF77}"/>
              </a:ext>
            </a:extLst>
          </p:cNvPr>
          <p:cNvSpPr txBox="1"/>
          <p:nvPr/>
        </p:nvSpPr>
        <p:spPr>
          <a:xfrm>
            <a:off x="1963670" y="505886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FF274BE-A679-4A78-A82D-C2AD6F6D6A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0403698"/>
              </p:ext>
            </p:extLst>
          </p:nvPr>
        </p:nvGraphicFramePr>
        <p:xfrm>
          <a:off x="3216223" y="4652413"/>
          <a:ext cx="4010716" cy="984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647098" imgH="643027" progId="">
                  <p:embed/>
                </p:oleObj>
              </mc:Choice>
              <mc:Fallback>
                <p:oleObj r:id="rId8" imgW="2647098" imgH="64302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16223" y="4652413"/>
                        <a:ext cx="4010716" cy="984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EFD0DF43-D7D5-45A7-9102-F21B5606D257}"/>
              </a:ext>
            </a:extLst>
          </p:cNvPr>
          <p:cNvSpPr/>
          <p:nvPr/>
        </p:nvSpPr>
        <p:spPr>
          <a:xfrm>
            <a:off x="3441432" y="4810827"/>
            <a:ext cx="3513967" cy="54934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71513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29EC74C-0625-4F00-A791-14EE817AB13D}"/>
              </a:ext>
            </a:extLst>
          </p:cNvPr>
          <p:cNvSpPr txBox="1"/>
          <p:nvPr/>
        </p:nvSpPr>
        <p:spPr>
          <a:xfrm>
            <a:off x="583096" y="543339"/>
            <a:ext cx="1078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F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AD4181E-B303-49C8-BD6B-C4D12174D6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6091761"/>
              </p:ext>
            </p:extLst>
          </p:nvPr>
        </p:nvGraphicFramePr>
        <p:xfrm>
          <a:off x="3936998" y="1764060"/>
          <a:ext cx="4191381" cy="13252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158343" imgH="682813" progId="">
                  <p:embed/>
                </p:oleObj>
              </mc:Choice>
              <mc:Fallback>
                <p:oleObj r:id="rId2" imgW="2158343" imgH="682813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36998" y="1764060"/>
                        <a:ext cx="4191381" cy="13252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A528B57-207E-4112-AB93-2ADF55BDDB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2689102"/>
              </p:ext>
            </p:extLst>
          </p:nvPr>
        </p:nvGraphicFramePr>
        <p:xfrm>
          <a:off x="3936999" y="3089276"/>
          <a:ext cx="4191381" cy="13252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158343" imgH="682813" progId="">
                  <p:embed/>
                </p:oleObj>
              </mc:Choice>
              <mc:Fallback>
                <p:oleObj r:id="rId4" imgW="2158343" imgH="682813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36999" y="3089276"/>
                        <a:ext cx="4191381" cy="13252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E0B5D613-DCED-4477-891A-C09878470BB1}"/>
              </a:ext>
            </a:extLst>
          </p:cNvPr>
          <p:cNvSpPr/>
          <p:nvPr/>
        </p:nvSpPr>
        <p:spPr>
          <a:xfrm>
            <a:off x="6705601" y="2190573"/>
            <a:ext cx="107342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502D57E-279C-451A-AD8C-A8EEEB8865A5}"/>
              </a:ext>
            </a:extLst>
          </p:cNvPr>
          <p:cNvSpPr/>
          <p:nvPr/>
        </p:nvSpPr>
        <p:spPr>
          <a:xfrm>
            <a:off x="6677268" y="3398405"/>
            <a:ext cx="107342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1A7DAC-7D89-478B-AF04-725F11C72958}"/>
              </a:ext>
            </a:extLst>
          </p:cNvPr>
          <p:cNvSpPr txBox="1"/>
          <p:nvPr/>
        </p:nvSpPr>
        <p:spPr>
          <a:xfrm>
            <a:off x="2743200" y="2190573"/>
            <a:ext cx="1047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yclin D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8B3B03-CD59-456B-B4F3-D721EF0E06D1}"/>
              </a:ext>
            </a:extLst>
          </p:cNvPr>
          <p:cNvSpPr txBox="1"/>
          <p:nvPr/>
        </p:nvSpPr>
        <p:spPr>
          <a:xfrm>
            <a:off x="2951847" y="351277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158776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69A0019-D1AD-414E-B50B-DD55A844774C}"/>
              </a:ext>
            </a:extLst>
          </p:cNvPr>
          <p:cNvSpPr txBox="1"/>
          <p:nvPr/>
        </p:nvSpPr>
        <p:spPr>
          <a:xfrm>
            <a:off x="583096" y="543339"/>
            <a:ext cx="1140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G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03E94C9-16D7-4983-A428-056BF0B46D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7204169"/>
              </p:ext>
            </p:extLst>
          </p:nvPr>
        </p:nvGraphicFramePr>
        <p:xfrm>
          <a:off x="2744863" y="2006907"/>
          <a:ext cx="5012606" cy="1153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477128" imgH="570265" progId="">
                  <p:embed/>
                </p:oleObj>
              </mc:Choice>
              <mc:Fallback>
                <p:oleObj r:id="rId2" imgW="2477128" imgH="57026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44863" y="2006907"/>
                        <a:ext cx="5012606" cy="11535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57A45BB-D32C-4492-9DAD-5BCC9AB51F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8698074"/>
              </p:ext>
            </p:extLst>
          </p:nvPr>
        </p:nvGraphicFramePr>
        <p:xfrm>
          <a:off x="2744863" y="3230732"/>
          <a:ext cx="4889933" cy="1209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453102" imgH="606825" progId="">
                  <p:embed/>
                </p:oleObj>
              </mc:Choice>
              <mc:Fallback>
                <p:oleObj r:id="rId4" imgW="2453102" imgH="60682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44863" y="3230732"/>
                        <a:ext cx="4889933" cy="12090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BAFD936A-7640-4FB8-80A5-9D2674429AB1}"/>
              </a:ext>
            </a:extLst>
          </p:cNvPr>
          <p:cNvSpPr/>
          <p:nvPr/>
        </p:nvSpPr>
        <p:spPr>
          <a:xfrm>
            <a:off x="2846124" y="2388094"/>
            <a:ext cx="4687409" cy="648070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73C990E-4213-44C7-98FD-DA5A25290228}"/>
              </a:ext>
            </a:extLst>
          </p:cNvPr>
          <p:cNvSpPr/>
          <p:nvPr/>
        </p:nvSpPr>
        <p:spPr>
          <a:xfrm>
            <a:off x="2783977" y="3567530"/>
            <a:ext cx="4687409" cy="648070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8B51F6A-FC65-41D2-8112-4B6729F252BB}"/>
              </a:ext>
            </a:extLst>
          </p:cNvPr>
          <p:cNvSpPr txBox="1"/>
          <p:nvPr/>
        </p:nvSpPr>
        <p:spPr>
          <a:xfrm>
            <a:off x="1574850" y="2527463"/>
            <a:ext cx="1047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yclin D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DE15EE-9D85-4F6B-A208-ADB5FB35BA36}"/>
              </a:ext>
            </a:extLst>
          </p:cNvPr>
          <p:cNvSpPr txBox="1"/>
          <p:nvPr/>
        </p:nvSpPr>
        <p:spPr>
          <a:xfrm>
            <a:off x="1767396" y="3706899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22346572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2F2D093-F2C4-405E-8135-702AB264C59C}"/>
              </a:ext>
            </a:extLst>
          </p:cNvPr>
          <p:cNvSpPr txBox="1"/>
          <p:nvPr/>
        </p:nvSpPr>
        <p:spPr>
          <a:xfrm>
            <a:off x="0" y="161599"/>
            <a:ext cx="1140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G.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A1AAF22-DCA3-4C29-91FB-B829105077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282780"/>
              </p:ext>
            </p:extLst>
          </p:nvPr>
        </p:nvGraphicFramePr>
        <p:xfrm>
          <a:off x="1717167" y="1848475"/>
          <a:ext cx="3121163" cy="864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632038" imgH="728334" progId="">
                  <p:embed/>
                </p:oleObj>
              </mc:Choice>
              <mc:Fallback>
                <p:oleObj r:id="rId2" imgW="2632038" imgH="7283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17167" y="1848475"/>
                        <a:ext cx="3121163" cy="864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130CA00D-F2A6-4D07-BAB5-44E02724C4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6710005"/>
              </p:ext>
            </p:extLst>
          </p:nvPr>
        </p:nvGraphicFramePr>
        <p:xfrm>
          <a:off x="1717166" y="2780557"/>
          <a:ext cx="3121163" cy="932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641361" imgH="788909" progId="">
                  <p:embed/>
                </p:oleObj>
              </mc:Choice>
              <mc:Fallback>
                <p:oleObj r:id="rId4" imgW="2641361" imgH="78890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17166" y="2780557"/>
                        <a:ext cx="3121163" cy="932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1772EBB7-6413-446D-B622-4F5E7B65B11D}"/>
              </a:ext>
            </a:extLst>
          </p:cNvPr>
          <p:cNvSpPr/>
          <p:nvPr/>
        </p:nvSpPr>
        <p:spPr>
          <a:xfrm>
            <a:off x="3889191" y="2997600"/>
            <a:ext cx="815974" cy="466911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4FF5A55-6298-4A78-8148-A4C53A74B7D3}"/>
              </a:ext>
            </a:extLst>
          </p:cNvPr>
          <p:cNvSpPr/>
          <p:nvPr/>
        </p:nvSpPr>
        <p:spPr>
          <a:xfrm>
            <a:off x="3889191" y="1971669"/>
            <a:ext cx="815974" cy="466911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5457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BE71056-9A6A-43B1-8F2A-C631A765DBE6}"/>
              </a:ext>
            </a:extLst>
          </p:cNvPr>
          <p:cNvSpPr txBox="1"/>
          <p:nvPr/>
        </p:nvSpPr>
        <p:spPr>
          <a:xfrm>
            <a:off x="583096" y="543339"/>
            <a:ext cx="1119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7B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634C6ED-2879-4102-8988-CAB8589037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432146"/>
              </p:ext>
            </p:extLst>
          </p:nvPr>
        </p:nvGraphicFramePr>
        <p:xfrm>
          <a:off x="3268102" y="1181335"/>
          <a:ext cx="3210477" cy="16186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517904" imgH="764536" progId="">
                  <p:embed/>
                </p:oleObj>
              </mc:Choice>
              <mc:Fallback>
                <p:oleObj r:id="rId2" imgW="1517904" imgH="764536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8102" y="1181335"/>
                        <a:ext cx="3210477" cy="16186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C6D5599-1CBC-49CE-82D1-74685A17BF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623920"/>
              </p:ext>
            </p:extLst>
          </p:nvPr>
        </p:nvGraphicFramePr>
        <p:xfrm>
          <a:off x="3268102" y="4522618"/>
          <a:ext cx="3210476" cy="1605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1505712" imgH="752349" progId="">
                  <p:embed/>
                </p:oleObj>
              </mc:Choice>
              <mc:Fallback>
                <p:oleObj r:id="rId4" imgW="1505712" imgH="75234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68102" y="4522618"/>
                        <a:ext cx="3210476" cy="1605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B6D152D-165F-4175-AE19-16B3C8E051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4138"/>
              </p:ext>
            </p:extLst>
          </p:nvPr>
        </p:nvGraphicFramePr>
        <p:xfrm>
          <a:off x="3268102" y="2917380"/>
          <a:ext cx="3210475" cy="1605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1505712" imgH="752349" progId="">
                  <p:embed/>
                </p:oleObj>
              </mc:Choice>
              <mc:Fallback>
                <p:oleObj r:id="rId6" imgW="1505712" imgH="75234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68102" y="2917380"/>
                        <a:ext cx="3210475" cy="1605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EB936D57-2963-48BF-A4F7-CC2722A0DC95}"/>
              </a:ext>
            </a:extLst>
          </p:cNvPr>
          <p:cNvSpPr/>
          <p:nvPr/>
        </p:nvSpPr>
        <p:spPr>
          <a:xfrm>
            <a:off x="3372782" y="1511096"/>
            <a:ext cx="1172714" cy="669925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FE34F21-368B-426A-A178-A55A7969B437}"/>
              </a:ext>
            </a:extLst>
          </p:cNvPr>
          <p:cNvSpPr/>
          <p:nvPr/>
        </p:nvSpPr>
        <p:spPr>
          <a:xfrm>
            <a:off x="3425790" y="3311293"/>
            <a:ext cx="1172714" cy="669925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D067874-D7CC-4F3D-8F46-AD154155A090}"/>
              </a:ext>
            </a:extLst>
          </p:cNvPr>
          <p:cNvSpPr/>
          <p:nvPr/>
        </p:nvSpPr>
        <p:spPr>
          <a:xfrm>
            <a:off x="3425790" y="4946876"/>
            <a:ext cx="1172714" cy="669925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D097754-003E-4C25-AAD8-FDCE4FE89669}"/>
              </a:ext>
            </a:extLst>
          </p:cNvPr>
          <p:cNvSpPr txBox="1"/>
          <p:nvPr/>
        </p:nvSpPr>
        <p:spPr>
          <a:xfrm>
            <a:off x="2219340" y="1621338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K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130897D-3FB3-44B2-9E2D-AA08324133DA}"/>
              </a:ext>
            </a:extLst>
          </p:cNvPr>
          <p:cNvSpPr txBox="1"/>
          <p:nvPr/>
        </p:nvSpPr>
        <p:spPr>
          <a:xfrm>
            <a:off x="2502951" y="3611886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K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812935-1FEB-4317-8DC9-E2CEC2DB445C}"/>
              </a:ext>
            </a:extLst>
          </p:cNvPr>
          <p:cNvSpPr txBox="1"/>
          <p:nvPr/>
        </p:nvSpPr>
        <p:spPr>
          <a:xfrm>
            <a:off x="2240659" y="5161998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0994657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82028B4-48DC-4AD0-9E97-DB69FEF6E947}"/>
              </a:ext>
            </a:extLst>
          </p:cNvPr>
          <p:cNvSpPr txBox="1"/>
          <p:nvPr/>
        </p:nvSpPr>
        <p:spPr>
          <a:xfrm>
            <a:off x="583096" y="543339"/>
            <a:ext cx="1119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7C.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FE43C7E-DFBA-4BB8-9408-72D86DAE33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403959"/>
              </p:ext>
            </p:extLst>
          </p:nvPr>
        </p:nvGraphicFramePr>
        <p:xfrm>
          <a:off x="3680034" y="1432819"/>
          <a:ext cx="2427080" cy="14164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432919" imgH="837297" progId="">
                  <p:embed/>
                </p:oleObj>
              </mc:Choice>
              <mc:Fallback>
                <p:oleObj r:id="rId2" imgW="1432919" imgH="83729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80034" y="1432819"/>
                        <a:ext cx="2427080" cy="14164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06BC711-B734-4334-96D6-EE6C46A266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3638037"/>
              </p:ext>
            </p:extLst>
          </p:nvPr>
        </p:nvGraphicFramePr>
        <p:xfrm>
          <a:off x="3657808" y="2849288"/>
          <a:ext cx="2427080" cy="1426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1445111" imgH="849484" progId="">
                  <p:embed/>
                </p:oleObj>
              </mc:Choice>
              <mc:Fallback>
                <p:oleObj r:id="rId4" imgW="1445111" imgH="84948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57808" y="2849288"/>
                        <a:ext cx="2427080" cy="1426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27264D2-D5C8-461D-9964-C8971D009755}"/>
              </a:ext>
            </a:extLst>
          </p:cNvPr>
          <p:cNvSpPr/>
          <p:nvPr/>
        </p:nvSpPr>
        <p:spPr>
          <a:xfrm>
            <a:off x="4804015" y="1915729"/>
            <a:ext cx="107342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DC6197A-18B7-472D-9AFD-D30C9A88DB1E}"/>
              </a:ext>
            </a:extLst>
          </p:cNvPr>
          <p:cNvSpPr/>
          <p:nvPr/>
        </p:nvSpPr>
        <p:spPr>
          <a:xfrm>
            <a:off x="4777566" y="3199318"/>
            <a:ext cx="1073426" cy="59807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3BD114-407C-473A-8F14-950679E93021}"/>
              </a:ext>
            </a:extLst>
          </p:cNvPr>
          <p:cNvSpPr txBox="1"/>
          <p:nvPr/>
        </p:nvSpPr>
        <p:spPr>
          <a:xfrm>
            <a:off x="2551862" y="2059125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K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20BFF0-7772-4A4C-8DB7-88C64ADFB5EA}"/>
              </a:ext>
            </a:extLst>
          </p:cNvPr>
          <p:cNvSpPr txBox="1"/>
          <p:nvPr/>
        </p:nvSpPr>
        <p:spPr>
          <a:xfrm>
            <a:off x="2585221" y="324433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28457730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F898535-E5EC-4FAF-893C-47D341DA0235}"/>
              </a:ext>
            </a:extLst>
          </p:cNvPr>
          <p:cNvSpPr/>
          <p:nvPr/>
        </p:nvSpPr>
        <p:spPr>
          <a:xfrm>
            <a:off x="352012" y="302351"/>
            <a:ext cx="24690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6B.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434FD08-BFE7-486E-9A43-54028DDCF5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2424750"/>
              </p:ext>
            </p:extLst>
          </p:nvPr>
        </p:nvGraphicFramePr>
        <p:xfrm>
          <a:off x="3791501" y="1359737"/>
          <a:ext cx="4946974" cy="14762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197787" imgH="655214" progId="">
                  <p:embed/>
                </p:oleObj>
              </mc:Choice>
              <mc:Fallback>
                <p:oleObj r:id="rId2" imgW="2197787" imgH="65521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91501" y="1359737"/>
                        <a:ext cx="4946974" cy="14762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AE3486E-FE2B-426C-86FA-018B46A1C5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8770754"/>
              </p:ext>
            </p:extLst>
          </p:nvPr>
        </p:nvGraphicFramePr>
        <p:xfrm>
          <a:off x="3667914" y="2986769"/>
          <a:ext cx="4856172" cy="10336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222171" imgH="473130" progId="">
                  <p:embed/>
                </p:oleObj>
              </mc:Choice>
              <mc:Fallback>
                <p:oleObj r:id="rId4" imgW="2222171" imgH="47313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67914" y="2986769"/>
                        <a:ext cx="4856172" cy="10336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311A16B-512F-4D47-9991-439E199360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6671223"/>
              </p:ext>
            </p:extLst>
          </p:nvPr>
        </p:nvGraphicFramePr>
        <p:xfrm>
          <a:off x="3791501" y="4171245"/>
          <a:ext cx="4773594" cy="14762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197787" imgH="679587" progId="">
                  <p:embed/>
                </p:oleObj>
              </mc:Choice>
              <mc:Fallback>
                <p:oleObj r:id="rId6" imgW="2197787" imgH="679587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91501" y="4171245"/>
                        <a:ext cx="4773594" cy="14762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D0D15A46-C2EB-40B5-9F4E-E7E104D77024}"/>
              </a:ext>
            </a:extLst>
          </p:cNvPr>
          <p:cNvSpPr/>
          <p:nvPr/>
        </p:nvSpPr>
        <p:spPr>
          <a:xfrm>
            <a:off x="6189819" y="1815548"/>
            <a:ext cx="2375276" cy="71561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45F9B9B-608A-4252-B233-050C1992AE29}"/>
              </a:ext>
            </a:extLst>
          </p:cNvPr>
          <p:cNvSpPr/>
          <p:nvPr/>
        </p:nvSpPr>
        <p:spPr>
          <a:xfrm>
            <a:off x="5984410" y="3150829"/>
            <a:ext cx="2375276" cy="71561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1C47AC9-BE20-4EAA-8D76-CCC0CFA24A21}"/>
              </a:ext>
            </a:extLst>
          </p:cNvPr>
          <p:cNvSpPr/>
          <p:nvPr/>
        </p:nvSpPr>
        <p:spPr>
          <a:xfrm>
            <a:off x="6096000" y="4591305"/>
            <a:ext cx="2375276" cy="715617"/>
          </a:xfrm>
          <a:prstGeom prst="rect">
            <a:avLst/>
          </a:prstGeom>
          <a:noFill/>
          <a:ln w="381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73B480B-5442-439A-B08F-D387A6C8C62B}"/>
              </a:ext>
            </a:extLst>
          </p:cNvPr>
          <p:cNvSpPr txBox="1"/>
          <p:nvPr/>
        </p:nvSpPr>
        <p:spPr>
          <a:xfrm>
            <a:off x="2937333" y="3318938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K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BF7203-330F-41B6-9295-6D3A59FC20B5}"/>
              </a:ext>
            </a:extLst>
          </p:cNvPr>
          <p:cNvSpPr txBox="1"/>
          <p:nvPr/>
        </p:nvSpPr>
        <p:spPr>
          <a:xfrm>
            <a:off x="2937333" y="1913184"/>
            <a:ext cx="773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RT2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FE4D14-EB2E-4227-BA04-4CDFDD84583F}"/>
              </a:ext>
            </a:extLst>
          </p:cNvPr>
          <p:cNvSpPr txBox="1"/>
          <p:nvPr/>
        </p:nvSpPr>
        <p:spPr>
          <a:xfrm>
            <a:off x="2829223" y="4724692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2969549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49</Words>
  <Application>Microsoft Macintosh PowerPoint</Application>
  <PresentationFormat>Widescreen</PresentationFormat>
  <Paragraphs>28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Chang</dc:creator>
  <cp:lastModifiedBy>Watts, Brenton G.</cp:lastModifiedBy>
  <cp:revision>13</cp:revision>
  <dcterms:created xsi:type="dcterms:W3CDTF">2025-04-19T15:39:05Z</dcterms:created>
  <dcterms:modified xsi:type="dcterms:W3CDTF">2025-04-25T15:47:33Z</dcterms:modified>
</cp:coreProperties>
</file>